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2" d="100"/>
          <a:sy n="102" d="100"/>
        </p:scale>
        <p:origin x="-127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KATERINA:Katerina2%20FACS:Katerina:bead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6757799268916"/>
          <c:y val="0.053890617091928"/>
          <c:w val="0.760162070317605"/>
          <c:h val="0.786402765284144"/>
        </c:manualLayout>
      </c:layout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-0.0679188423508499"/>
                  <c:y val="-0.00268652945371661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>
                      <a:latin typeface="Arial"/>
                      <a:cs typeface="Arial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G$3:$G$6</c:f>
              <c:numCache>
                <c:formatCode>General</c:formatCode>
                <c:ptCount val="4"/>
                <c:pt idx="0">
                  <c:v>2.675778341674085</c:v>
                </c:pt>
                <c:pt idx="1">
                  <c:v>3.729083757043612</c:v>
                </c:pt>
                <c:pt idx="2">
                  <c:v>4.377360898781112</c:v>
                </c:pt>
                <c:pt idx="3">
                  <c:v>4.7947389308625</c:v>
                </c:pt>
              </c:numCache>
            </c:numRef>
          </c:xVal>
          <c:yVal>
            <c:numRef>
              <c:f>Sheet1!$D$3:$D$6</c:f>
              <c:numCache>
                <c:formatCode>General</c:formatCode>
                <c:ptCount val="4"/>
                <c:pt idx="0">
                  <c:v>1.64640372622307</c:v>
                </c:pt>
                <c:pt idx="1">
                  <c:v>2.706717782336758</c:v>
                </c:pt>
                <c:pt idx="2">
                  <c:v>3.346939462698991</c:v>
                </c:pt>
                <c:pt idx="3">
                  <c:v>3.7767011839884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1103976"/>
        <c:axId val="2091109528"/>
      </c:scatterChart>
      <c:valAx>
        <c:axId val="20911039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>
                    <a:latin typeface="Arial"/>
                    <a:cs typeface="Arial"/>
                  </a:defRPr>
                </a:pPr>
                <a:r>
                  <a:rPr lang="en-US" b="0">
                    <a:latin typeface="Arial"/>
                    <a:cs typeface="Arial"/>
                  </a:rPr>
                  <a:t>log molecules/bead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2091109528"/>
        <c:crosses val="autoZero"/>
        <c:crossBetween val="midCat"/>
      </c:valAx>
      <c:valAx>
        <c:axId val="20911095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>
                    <a:latin typeface="Arial"/>
                    <a:cs typeface="Arial"/>
                  </a:defRPr>
                </a:pPr>
                <a:r>
                  <a:rPr lang="en-US" b="0" dirty="0">
                    <a:latin typeface="Arial"/>
                    <a:cs typeface="Arial"/>
                  </a:rPr>
                  <a:t>log geometric mean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209110397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505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528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56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013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862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337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041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566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743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191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713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5D834C-D9CF-9843-958F-9BACEB422955}" type="datetimeFigureOut">
              <a:rPr lang="en-US" smtClean="0"/>
              <a:t>09/0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A8037-4C74-E048-AF15-9D3010178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326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8278378"/>
              </p:ext>
            </p:extLst>
          </p:nvPr>
        </p:nvGraphicFramePr>
        <p:xfrm>
          <a:off x="5580112" y="188640"/>
          <a:ext cx="2880320" cy="2232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51520" y="3212976"/>
            <a:ext cx="80648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antibrit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eads used to calculate fluorescence intensity. A)Forwar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de scatter of beads run on the same settings as data acquisition. B) bea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ed to calculate geometric means of low, medium low, medium high and high fluorescence bea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C) standard curve to convert fluorescence intensity to number of receptors per cell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771800" y="234888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07504" y="234888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512" y="116632"/>
            <a:ext cx="2520280" cy="235687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71800" y="188640"/>
            <a:ext cx="2616200" cy="22733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580112" y="234888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294934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icos Shangaris</dc:creator>
  <cp:lastModifiedBy>Panicos Shangaris</cp:lastModifiedBy>
  <cp:revision>2</cp:revision>
  <dcterms:created xsi:type="dcterms:W3CDTF">2014-06-09T09:51:17Z</dcterms:created>
  <dcterms:modified xsi:type="dcterms:W3CDTF">2014-06-09T09:52:04Z</dcterms:modified>
</cp:coreProperties>
</file>